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F4CD1C-81A0-4E8A-9CC6-DE213D4ED24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3C180D-865C-4CE7-AE6C-E2B067731B6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74839E-B0A1-460E-B8CD-DB8832DBCBD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715616-112B-49F4-94A4-BA4F1250983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7DE71B-0922-487E-8F59-DB49D7CA071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B20583-A407-4FFF-8CB1-4A2871F85DE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F133A9-9F98-45C0-96DB-949701A0645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5E4578-8A01-4DC2-A762-A839288C855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361680-DF4A-4F59-8C93-359877E10A7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C62DD3-D7E9-46D6-8ED6-684FF69BF7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AE98D1-8903-4F85-976B-D71EE42709C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56F1B9-4E0C-493E-B358-95664377E67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89D6D47-BE24-495F-944A-7FED90774C42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34"/>
          <p:cNvSpPr/>
          <p:nvPr/>
        </p:nvSpPr>
        <p:spPr>
          <a:xfrm>
            <a:off x="0" y="0"/>
            <a:ext cx="91440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 1"/>
          <p:cNvGrpSpPr/>
          <p:nvPr/>
        </p:nvGrpSpPr>
        <p:grpSpPr>
          <a:xfrm>
            <a:off x="1440" y="333360"/>
            <a:ext cx="9107280" cy="5915160"/>
            <a:chOff x="1440" y="333360"/>
            <a:chExt cx="9107280" cy="5915160"/>
          </a:xfrm>
        </p:grpSpPr>
        <p:sp>
          <p:nvSpPr>
            <p:cNvPr id="43" name="Text Box 33"/>
            <p:cNvSpPr/>
            <p:nvPr/>
          </p:nvSpPr>
          <p:spPr>
            <a:xfrm>
              <a:off x="3974760" y="921960"/>
              <a:ext cx="1817640" cy="2005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it-IT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Randomized (n=433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4" name="Immagine 22" descr=""/>
            <p:cNvPicPr/>
            <p:nvPr/>
          </p:nvPicPr>
          <p:blipFill>
            <a:blip r:embed="rId1"/>
            <a:stretch/>
          </p:blipFill>
          <p:spPr>
            <a:xfrm>
              <a:off x="1440" y="333360"/>
              <a:ext cx="375120" cy="1495440"/>
            </a:xfrm>
            <a:prstGeom prst="rect">
              <a:avLst/>
            </a:prstGeom>
            <a:ln w="0">
              <a:noFill/>
            </a:ln>
          </p:spPr>
        </p:pic>
        <p:cxnSp>
          <p:nvCxnSpPr>
            <p:cNvPr id="45" name="AutoShape 31"/>
            <p:cNvCxnSpPr/>
            <p:nvPr/>
          </p:nvCxnSpPr>
          <p:spPr>
            <a:xfrm>
              <a:off x="1539000" y="1575000"/>
              <a:ext cx="3299400" cy="144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cxnSp>
          <p:nvCxnSpPr>
            <p:cNvPr id="46" name="AutoShape 30"/>
            <p:cNvCxnSpPr/>
            <p:nvPr/>
          </p:nvCxnSpPr>
          <p:spPr>
            <a:xfrm>
              <a:off x="4864680" y="1139760"/>
              <a:ext cx="1080" cy="43524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47" name="AutoShape 29"/>
            <p:cNvCxnSpPr/>
            <p:nvPr/>
          </p:nvCxnSpPr>
          <p:spPr>
            <a:xfrm>
              <a:off x="1530360" y="1582200"/>
              <a:ext cx="1080" cy="32400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48" name="AutoShape 28"/>
            <p:cNvCxnSpPr/>
            <p:nvPr/>
          </p:nvCxnSpPr>
          <p:spPr>
            <a:xfrm>
              <a:off x="8129160" y="1567800"/>
              <a:ext cx="1080" cy="32400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49" name="AutoShape 27"/>
            <p:cNvCxnSpPr/>
            <p:nvPr/>
          </p:nvCxnSpPr>
          <p:spPr>
            <a:xfrm>
              <a:off x="4838760" y="1575000"/>
              <a:ext cx="3299400" cy="144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cxnSp>
          <p:nvCxnSpPr>
            <p:cNvPr id="50" name="AutoShape 26"/>
            <p:cNvCxnSpPr/>
            <p:nvPr/>
          </p:nvCxnSpPr>
          <p:spPr>
            <a:xfrm>
              <a:off x="3738600" y="1582200"/>
              <a:ext cx="1080" cy="32400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51" name="AutoShape 25"/>
            <p:cNvCxnSpPr/>
            <p:nvPr/>
          </p:nvCxnSpPr>
          <p:spPr>
            <a:xfrm>
              <a:off x="5947200" y="1582200"/>
              <a:ext cx="1080" cy="32400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52" name="Text Box 24"/>
            <p:cNvSpPr/>
            <p:nvPr/>
          </p:nvSpPr>
          <p:spPr>
            <a:xfrm>
              <a:off x="555840" y="1977840"/>
              <a:ext cx="1943280" cy="11523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Allocated to </a:t>
              </a:r>
              <a:r>
                <a:rPr b="0" lang="en-GB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gemcitabine plus cisplatin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(GP) (n=106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buClr>
                  <a:srgbClr val="000000"/>
                </a:buClr>
                <a:buFont typeface="Arial"/>
                <a:buChar char="•"/>
                <a:tabLst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Received allocated treatment (n=100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buClr>
                  <a:srgbClr val="000000"/>
                </a:buClr>
                <a:buFont typeface="Arial"/>
                <a:buChar char="•"/>
                <a:tabLst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Did not received allocated treatment (n=6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     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refusal or medical decision after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     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randomization (n=5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     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treated with gemcitabine plus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	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  vinorelbine (n=1)*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 Box 23"/>
            <p:cNvSpPr/>
            <p:nvPr/>
          </p:nvSpPr>
          <p:spPr>
            <a:xfrm>
              <a:off x="7155000" y="1968480"/>
              <a:ext cx="1943640" cy="11523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Allocated to </a:t>
              </a:r>
              <a:r>
                <a:rPr b="0" lang="en-GB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gemcitabine plus ifosfamide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plus vinorelbine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(GIN) (n=111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buClr>
                  <a:srgbClr val="000000"/>
                </a:buClr>
                <a:buFont typeface="Arial"/>
                <a:buChar char="•"/>
                <a:tabLst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Received allocated treatment (n=107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buClr>
                  <a:srgbClr val="000000"/>
                </a:buClr>
                <a:buFont typeface="Arial"/>
                <a:buChar char="•"/>
                <a:tabLst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Did not received allocated treatment (n=4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     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refusal or medical decision after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     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randomization (n=4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 Box 22"/>
            <p:cNvSpPr/>
            <p:nvPr/>
          </p:nvSpPr>
          <p:spPr>
            <a:xfrm>
              <a:off x="2766240" y="1979640"/>
              <a:ext cx="1943640" cy="11523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Allocated to </a:t>
              </a:r>
              <a:r>
                <a:rPr b="0" lang="en-GB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gemcitabine plus vinorelbine (GN)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(n=106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buClr>
                  <a:srgbClr val="000000"/>
                </a:buClr>
                <a:buFont typeface="Arial"/>
                <a:buChar char="•"/>
                <a:tabLst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Received allocated treatment (n=102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buClr>
                  <a:srgbClr val="000000"/>
                </a:buClr>
                <a:buFont typeface="Arial"/>
                <a:buChar char="•"/>
                <a:tabLst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Did not received allocated treatment (n=4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    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refusal or medical decision after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    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randomization (n=4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 Box 21"/>
            <p:cNvSpPr/>
            <p:nvPr/>
          </p:nvSpPr>
          <p:spPr>
            <a:xfrm>
              <a:off x="4972680" y="1968480"/>
              <a:ext cx="1943280" cy="115236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Allocated to </a:t>
              </a:r>
              <a:r>
                <a:rPr b="0" lang="en-GB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gemcitabine plus ifosfamide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plus cisplatin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tabLst>
                  <a:tab algn="l" pos="0"/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(GIP) (n=110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buClr>
                  <a:srgbClr val="000000"/>
                </a:buClr>
                <a:buFont typeface="Arial"/>
                <a:buChar char="•"/>
                <a:tabLst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Received allocated treatment (n=107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buClr>
                  <a:srgbClr val="000000"/>
                </a:buClr>
                <a:buFont typeface="Arial"/>
                <a:buChar char="•"/>
                <a:tabLst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Did not received allocated treatment (n=3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     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refusal or medical decision after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     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randomization (n=3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6" name="Immagine 19" descr=""/>
            <p:cNvPicPr/>
            <p:nvPr/>
          </p:nvPicPr>
          <p:blipFill>
            <a:blip r:embed="rId2"/>
            <a:stretch/>
          </p:blipFill>
          <p:spPr>
            <a:xfrm>
              <a:off x="3240" y="1820880"/>
              <a:ext cx="375120" cy="1465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7" name="Immagine 25" descr=""/>
            <p:cNvPicPr/>
            <p:nvPr/>
          </p:nvPicPr>
          <p:blipFill>
            <a:blip r:embed="rId3"/>
            <a:stretch/>
          </p:blipFill>
          <p:spPr>
            <a:xfrm>
              <a:off x="20520" y="3316320"/>
              <a:ext cx="357840" cy="1426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8" name="Immagine 28" descr=""/>
            <p:cNvPicPr/>
            <p:nvPr/>
          </p:nvPicPr>
          <p:blipFill>
            <a:blip r:embed="rId4"/>
            <a:stretch/>
          </p:blipFill>
          <p:spPr>
            <a:xfrm>
              <a:off x="37800" y="4812120"/>
              <a:ext cx="322920" cy="1436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9" name="Text Box 17"/>
            <p:cNvSpPr/>
            <p:nvPr/>
          </p:nvSpPr>
          <p:spPr>
            <a:xfrm>
              <a:off x="566280" y="3696840"/>
              <a:ext cx="1943640" cy="6721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buClr>
                  <a:srgbClr val="000000"/>
                </a:buClr>
                <a:buFont typeface="Arial"/>
                <a:buChar char="•"/>
                <a:tabLst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Follow-up completed (n=94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buClr>
                  <a:srgbClr val="000000"/>
                </a:buClr>
                <a:buFont typeface="Arial"/>
                <a:buChar char="•"/>
                <a:tabLst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Follow-up not completed (n=12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lost to follow-up (n=12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 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treated (n=9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 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not treated (n=3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 Box 16"/>
            <p:cNvSpPr/>
            <p:nvPr/>
          </p:nvSpPr>
          <p:spPr>
            <a:xfrm>
              <a:off x="2774880" y="3696840"/>
              <a:ext cx="1943640" cy="6721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buClr>
                  <a:srgbClr val="000000"/>
                </a:buClr>
                <a:buFont typeface="Arial"/>
                <a:buChar char="•"/>
                <a:tabLst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Follow-up completed (n=102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buClr>
                  <a:srgbClr val="000000"/>
                </a:buClr>
                <a:buFont typeface="Arial"/>
                <a:buChar char="•"/>
                <a:tabLst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Follow-up not completed (n=4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lost to follow-up (n=4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 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treated (n=4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 Box 15"/>
            <p:cNvSpPr/>
            <p:nvPr/>
          </p:nvSpPr>
          <p:spPr>
            <a:xfrm>
              <a:off x="4983120" y="3696840"/>
              <a:ext cx="1943640" cy="6721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buClr>
                  <a:srgbClr val="000000"/>
                </a:buClr>
                <a:buFont typeface="Arial"/>
                <a:buChar char="•"/>
                <a:tabLst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Follow-up completed (n=100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buClr>
                  <a:srgbClr val="000000"/>
                </a:buClr>
                <a:buFont typeface="Arial"/>
                <a:buChar char="•"/>
                <a:tabLst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Follow-up not completed (n=10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lost to follow-up (n=10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 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treated (n=8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 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not treated (n=2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Text Box 14"/>
            <p:cNvSpPr/>
            <p:nvPr/>
          </p:nvSpPr>
          <p:spPr>
            <a:xfrm>
              <a:off x="7165440" y="3696840"/>
              <a:ext cx="1943280" cy="67212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buClr>
                  <a:srgbClr val="000000"/>
                </a:buClr>
                <a:buFont typeface="Arial"/>
                <a:buChar char="•"/>
                <a:tabLst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Follow-up completed (n=108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buClr>
                  <a:srgbClr val="000000"/>
                </a:buClr>
                <a:buFont typeface="Arial"/>
                <a:buChar char="•"/>
                <a:tabLst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Follow-up not completed (n=3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lost to follow-up (n=3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 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treated (n=2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 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not treated (n=1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63" name="AutoShape 13"/>
            <p:cNvCxnSpPr/>
            <p:nvPr/>
          </p:nvCxnSpPr>
          <p:spPr>
            <a:xfrm>
              <a:off x="1539000" y="3195720"/>
              <a:ext cx="1080" cy="44640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64" name="AutoShape 12"/>
            <p:cNvCxnSpPr/>
            <p:nvPr/>
          </p:nvCxnSpPr>
          <p:spPr>
            <a:xfrm>
              <a:off x="3729960" y="3195720"/>
              <a:ext cx="1080" cy="44640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65" name="AutoShape 11"/>
            <p:cNvCxnSpPr/>
            <p:nvPr/>
          </p:nvCxnSpPr>
          <p:spPr>
            <a:xfrm>
              <a:off x="5955840" y="3195720"/>
              <a:ext cx="1080" cy="44640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66" name="AutoShape 10"/>
            <p:cNvCxnSpPr/>
            <p:nvPr/>
          </p:nvCxnSpPr>
          <p:spPr>
            <a:xfrm>
              <a:off x="8155440" y="3195720"/>
              <a:ext cx="1080" cy="44640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sp>
          <p:nvSpPr>
            <p:cNvPr id="67" name="Text Box 9"/>
            <p:cNvSpPr/>
            <p:nvPr/>
          </p:nvSpPr>
          <p:spPr>
            <a:xfrm>
              <a:off x="566280" y="5369400"/>
              <a:ext cx="1943640" cy="3718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buClr>
                  <a:srgbClr val="000000"/>
                </a:buClr>
                <a:buFont typeface="Arial"/>
                <a:buChar char="•"/>
                <a:tabLst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Analyzed according to ITT principle (n=106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buClr>
                  <a:srgbClr val="000000"/>
                </a:buClr>
                <a:buFont typeface="Arial"/>
                <a:buChar char="•"/>
                <a:tabLst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Analyzed for safety (n=100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Text Box 8"/>
            <p:cNvSpPr/>
            <p:nvPr/>
          </p:nvSpPr>
          <p:spPr>
            <a:xfrm>
              <a:off x="2783520" y="5369400"/>
              <a:ext cx="1943640" cy="3718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buClr>
                  <a:srgbClr val="000000"/>
                </a:buClr>
                <a:buFont typeface="Arial"/>
                <a:buChar char="•"/>
                <a:tabLst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Analyzed according to ITT principle (n=106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buClr>
                  <a:srgbClr val="000000"/>
                </a:buClr>
                <a:buFont typeface="Arial"/>
                <a:buChar char="•"/>
                <a:tabLst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Analyzed for safety (n=103)*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Text Box 7"/>
            <p:cNvSpPr/>
            <p:nvPr/>
          </p:nvSpPr>
          <p:spPr>
            <a:xfrm>
              <a:off x="4991760" y="5369400"/>
              <a:ext cx="1943640" cy="3718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buClr>
                  <a:srgbClr val="000000"/>
                </a:buClr>
                <a:buFont typeface="Arial"/>
                <a:buChar char="•"/>
                <a:tabLst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Analyzed according to ITT principle (n=110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buClr>
                  <a:srgbClr val="000000"/>
                </a:buClr>
                <a:buFont typeface="Arial"/>
                <a:buChar char="•"/>
                <a:tabLst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Analyzed for safety (n=107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Text Box 6"/>
            <p:cNvSpPr/>
            <p:nvPr/>
          </p:nvSpPr>
          <p:spPr>
            <a:xfrm>
              <a:off x="7165440" y="5369400"/>
              <a:ext cx="1943280" cy="3718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buClr>
                  <a:srgbClr val="000000"/>
                </a:buClr>
                <a:buFont typeface="Arial"/>
                <a:buChar char="•"/>
                <a:tabLst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Analyzed according to ITT principle (n=111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buClr>
                  <a:srgbClr val="000000"/>
                </a:buClr>
                <a:buFont typeface="Arial"/>
                <a:buChar char="•"/>
                <a:tabLst>
                  <a:tab algn="l" pos="9036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  <a:ea typeface="Calibri"/>
                </a:rPr>
                <a:t>Analyzed for safety (n=107)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71" name="AutoShape 5"/>
            <p:cNvCxnSpPr/>
            <p:nvPr/>
          </p:nvCxnSpPr>
          <p:spPr>
            <a:xfrm>
              <a:off x="1539000" y="4504320"/>
              <a:ext cx="1080" cy="7444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72" name="AutoShape 4"/>
            <p:cNvCxnSpPr/>
            <p:nvPr/>
          </p:nvCxnSpPr>
          <p:spPr>
            <a:xfrm>
              <a:off x="3729960" y="4484880"/>
              <a:ext cx="1080" cy="7444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73" name="AutoShape 3"/>
            <p:cNvCxnSpPr/>
            <p:nvPr/>
          </p:nvCxnSpPr>
          <p:spPr>
            <a:xfrm>
              <a:off x="5955840" y="4494600"/>
              <a:ext cx="1080" cy="7444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  <p:cxnSp>
          <p:nvCxnSpPr>
            <p:cNvPr id="74" name="AutoShape 2"/>
            <p:cNvCxnSpPr/>
            <p:nvPr/>
          </p:nvCxnSpPr>
          <p:spPr>
            <a:xfrm>
              <a:off x="8155440" y="4494600"/>
              <a:ext cx="1080" cy="7444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  <a:tailEnd len="med" type="triangle" w="med"/>
            </a:ln>
          </p:spPr>
        </p:cxn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30T12:02:28Z</dcterms:created>
  <dc:creator>samsung</dc:creator>
  <dc:description/>
  <dc:language>en-US</dc:language>
  <cp:lastModifiedBy>samsung</cp:lastModifiedBy>
  <dcterms:modified xsi:type="dcterms:W3CDTF">2011-12-10T08:32:26Z</dcterms:modified>
  <cp:revision>5</cp:revision>
  <dc:subject/>
  <dc:title>Diapositiva 1</dc:title>
</cp:coreProperties>
</file>